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7"/>
  </p:notesMasterIdLst>
  <p:sldIdLst>
    <p:sldId id="303" r:id="rId5"/>
    <p:sldId id="302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0AD47"/>
    <a:srgbClr val="5AA155"/>
    <a:srgbClr val="AF7AA0"/>
    <a:srgbClr val="E0585B"/>
    <a:srgbClr val="F18F3B"/>
    <a:srgbClr val="4E79A5"/>
    <a:srgbClr val="EDC958"/>
    <a:srgbClr val="BAB0AC"/>
    <a:srgbClr val="9C7561"/>
    <a:srgbClr val="FE9EA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660B408-B3CF-4A94-85FC-2B1E0A45F4A2}" styleName="Dark Style 2 - Accent 1/Acc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91EBBBCC-DAD2-459C-BE2E-F6DE35CF9A28}" styleName="Dark Style 2 - Accent 3/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762" autoAdjust="0"/>
    <p:restoredTop sz="95816" autoAdjust="0"/>
  </p:normalViewPr>
  <p:slideViewPr>
    <p:cSldViewPr snapToGrid="0">
      <p:cViewPr varScale="1">
        <p:scale>
          <a:sx n="74" d="100"/>
          <a:sy n="74" d="100"/>
        </p:scale>
        <p:origin x="3048" y="6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180000" cy="180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notesMaster" Target="notesMasters/notesMaster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Users\maco\Desktop\EPS%20paper\Final%20draft\Data%20for%20figures\Fig%201B%20-%20RNAseq%20-%20Wzy%20genes%20-%20low%20Mg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Users\maco\Desktop\EPS%20paper\Final%20draft\Data%20for%20figures\Fig%201C%20-%20RNAseq%20-%20Wzy%20genes%20-%20low%20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1623680345168295"/>
          <c:y val="0.15409792887491694"/>
          <c:w val="0.76163940549261622"/>
          <c:h val="0.6382577843359084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Analysis!$B$2</c:f>
              <c:strCache>
                <c:ptCount val="1"/>
                <c:pt idx="0">
                  <c:v>Early growth, low Mg</c:v>
                </c:pt>
              </c:strCache>
            </c:strRef>
          </c:tx>
          <c:spPr>
            <a:solidFill>
              <a:schemeClr val="bg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Analysis!$G$3:$G$5</c:f>
                <c:numCache>
                  <c:formatCode>General</c:formatCode>
                  <c:ptCount val="3"/>
                  <c:pt idx="0">
                    <c:v>5.645898512489695</c:v>
                  </c:pt>
                  <c:pt idx="1">
                    <c:v>5.1341234312955457</c:v>
                  </c:pt>
                  <c:pt idx="2">
                    <c:v>1.2571965890822332</c:v>
                  </c:pt>
                </c:numCache>
              </c:numRef>
            </c:plus>
            <c:minus>
              <c:numRef>
                <c:f>Analysis!$G$3:$G$5</c:f>
                <c:numCache>
                  <c:formatCode>General</c:formatCode>
                  <c:ptCount val="3"/>
                  <c:pt idx="0">
                    <c:v>5.645898512489695</c:v>
                  </c:pt>
                  <c:pt idx="1">
                    <c:v>5.1341234312955457</c:v>
                  </c:pt>
                  <c:pt idx="2">
                    <c:v>1.2571965890822332</c:v>
                  </c:pt>
                </c:numCache>
              </c:numRef>
            </c:minus>
            <c:spPr>
              <a:ln>
                <a:solidFill>
                  <a:schemeClr val="tx1">
                    <a:lumMod val="85000"/>
                    <a:lumOff val="15000"/>
                  </a:schemeClr>
                </a:solidFill>
              </a:ln>
            </c:spPr>
          </c:errBars>
          <c:cat>
            <c:strRef>
              <c:f>Analysis!$B$3:$B$5</c:f>
              <c:strCache>
                <c:ptCount val="3"/>
                <c:pt idx="0">
                  <c:v>sll0923
p=0.010</c:v>
                </c:pt>
                <c:pt idx="1">
                  <c:v>sll1581
p&lt;0.001</c:v>
                </c:pt>
                <c:pt idx="2">
                  <c:v>slr1875
p&lt;0.001</c:v>
                </c:pt>
              </c:strCache>
            </c:strRef>
          </c:cat>
          <c:val>
            <c:numRef>
              <c:f>Analysis!$F$3:$F$5</c:f>
              <c:numCache>
                <c:formatCode>General</c:formatCode>
                <c:ptCount val="3"/>
                <c:pt idx="0">
                  <c:v>62.642400000000002</c:v>
                </c:pt>
                <c:pt idx="1">
                  <c:v>39.229366666666664</c:v>
                </c:pt>
                <c:pt idx="2">
                  <c:v>10.38015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183-8D49-89FE-8951AFC1874F}"/>
            </c:ext>
          </c:extLst>
        </c:ser>
        <c:ser>
          <c:idx val="1"/>
          <c:order val="1"/>
          <c:tx>
            <c:strRef>
              <c:f>Analysis!$B$7</c:f>
              <c:strCache>
                <c:ptCount val="1"/>
                <c:pt idx="0">
                  <c:v>Late growth, low Mg</c:v>
                </c:pt>
              </c:strCache>
            </c:strRef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Analysis!$G$8:$G$10</c:f>
                <c:numCache>
                  <c:formatCode>General</c:formatCode>
                  <c:ptCount val="3"/>
                  <c:pt idx="0">
                    <c:v>5.5907061275338421</c:v>
                  </c:pt>
                  <c:pt idx="1">
                    <c:v>6.7073282408123829</c:v>
                  </c:pt>
                  <c:pt idx="2">
                    <c:v>2.5213725237126776</c:v>
                  </c:pt>
                </c:numCache>
              </c:numRef>
            </c:plus>
            <c:minus>
              <c:numRef>
                <c:f>Analysis!$G$8:$G$10</c:f>
                <c:numCache>
                  <c:formatCode>General</c:formatCode>
                  <c:ptCount val="3"/>
                  <c:pt idx="0">
                    <c:v>5.5907061275338421</c:v>
                  </c:pt>
                  <c:pt idx="1">
                    <c:v>6.7073282408123829</c:v>
                  </c:pt>
                  <c:pt idx="2">
                    <c:v>2.5213725237126776</c:v>
                  </c:pt>
                </c:numCache>
              </c:numRef>
            </c:minus>
            <c:spPr>
              <a:ln>
                <a:solidFill>
                  <a:schemeClr val="tx1">
                    <a:lumMod val="85000"/>
                    <a:lumOff val="15000"/>
                  </a:schemeClr>
                </a:solidFill>
              </a:ln>
            </c:spPr>
          </c:errBars>
          <c:cat>
            <c:strRef>
              <c:f>Analysis!$B$3:$B$5</c:f>
              <c:strCache>
                <c:ptCount val="3"/>
                <c:pt idx="0">
                  <c:v>sll0923
p=0.010</c:v>
                </c:pt>
                <c:pt idx="1">
                  <c:v>sll1581
p&lt;0.001</c:v>
                </c:pt>
                <c:pt idx="2">
                  <c:v>slr1875
p&lt;0.001</c:v>
                </c:pt>
              </c:strCache>
            </c:strRef>
          </c:cat>
          <c:val>
            <c:numRef>
              <c:f>Analysis!$F$8:$F$10</c:f>
              <c:numCache>
                <c:formatCode>General</c:formatCode>
                <c:ptCount val="3"/>
                <c:pt idx="0">
                  <c:v>95.420933333333323</c:v>
                </c:pt>
                <c:pt idx="1">
                  <c:v>80.793000000000006</c:v>
                </c:pt>
                <c:pt idx="2">
                  <c:v>25.0281000000000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183-8D49-89FE-8951AFC1874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7402368"/>
        <c:axId val="127403904"/>
      </c:barChart>
      <c:catAx>
        <c:axId val="1274023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>
                <a:lumMod val="85000"/>
                <a:lumOff val="15000"/>
              </a:schemeClr>
            </a:solidFill>
          </a:ln>
        </c:spPr>
        <c:txPr>
          <a:bodyPr rot="0" vert="horz"/>
          <a:lstStyle/>
          <a:p>
            <a:pPr>
              <a:defRPr sz="1000"/>
            </a:pPr>
            <a:endParaRPr lang="en-US"/>
          </a:p>
        </c:txPr>
        <c:crossAx val="127403904"/>
        <c:crosses val="autoZero"/>
        <c:auto val="1"/>
        <c:lblAlgn val="ctr"/>
        <c:lblOffset val="100"/>
        <c:noMultiLvlLbl val="0"/>
      </c:catAx>
      <c:valAx>
        <c:axId val="1274039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>
                <a:lumMod val="85000"/>
                <a:lumOff val="15000"/>
              </a:schemeClr>
            </a:solidFill>
          </a:ln>
        </c:spPr>
        <c:txPr>
          <a:bodyPr/>
          <a:lstStyle/>
          <a:p>
            <a:pPr>
              <a:defRPr sz="1000"/>
            </a:pPr>
            <a:endParaRPr lang="en-US"/>
          </a:p>
        </c:txPr>
        <c:crossAx val="127402368"/>
        <c:crosses val="autoZero"/>
        <c:crossBetween val="between"/>
        <c:majorUnit val="40"/>
      </c:valAx>
      <c:spPr>
        <a:noFill/>
        <a:ln w="25400">
          <a:noFill/>
        </a:ln>
      </c:spPr>
    </c:plotArea>
    <c:legend>
      <c:legendPos val="t"/>
      <c:layout>
        <c:manualLayout>
          <c:xMode val="edge"/>
          <c:yMode val="edge"/>
          <c:x val="0.22653036791453698"/>
          <c:y val="0"/>
          <c:w val="0.75844775981949619"/>
          <c:h val="0.11825659832741997"/>
        </c:manualLayout>
      </c:layout>
      <c:overlay val="0"/>
      <c:txPr>
        <a:bodyPr/>
        <a:lstStyle/>
        <a:p>
          <a:pPr>
            <a:defRPr sz="1000"/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200"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1623680345168295"/>
          <c:y val="0.15409792887491694"/>
          <c:w val="0.76163940549261622"/>
          <c:h val="0.6382577843359084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Analysis!$B$2</c:f>
              <c:strCache>
                <c:ptCount val="1"/>
                <c:pt idx="0">
                  <c:v>Early growth, low 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Analysis!$G$3:$G$5</c:f>
                <c:numCache>
                  <c:formatCode>General</c:formatCode>
                  <c:ptCount val="3"/>
                  <c:pt idx="0">
                    <c:v>2.4258136822746943</c:v>
                  </c:pt>
                  <c:pt idx="1">
                    <c:v>1.9556026729487865</c:v>
                  </c:pt>
                  <c:pt idx="2">
                    <c:v>2.8400358278256483</c:v>
                  </c:pt>
                </c:numCache>
              </c:numRef>
            </c:plus>
            <c:minus>
              <c:numRef>
                <c:f>Analysis!$G$3:$G$5</c:f>
                <c:numCache>
                  <c:formatCode>General</c:formatCode>
                  <c:ptCount val="3"/>
                  <c:pt idx="0">
                    <c:v>2.4258136822746943</c:v>
                  </c:pt>
                  <c:pt idx="1">
                    <c:v>1.9556026729487865</c:v>
                  </c:pt>
                  <c:pt idx="2">
                    <c:v>2.8400358278256483</c:v>
                  </c:pt>
                </c:numCache>
              </c:numRef>
            </c:minus>
            <c:spPr>
              <a:ln>
                <a:solidFill>
                  <a:schemeClr val="tx1">
                    <a:lumMod val="85000"/>
                    <a:lumOff val="15000"/>
                  </a:schemeClr>
                </a:solidFill>
              </a:ln>
            </c:spPr>
          </c:errBars>
          <c:cat>
            <c:strRef>
              <c:f>Analysis!$B$3:$B$5</c:f>
              <c:strCache>
                <c:ptCount val="3"/>
                <c:pt idx="0">
                  <c:v>sll0923
p=0.003</c:v>
                </c:pt>
                <c:pt idx="1">
                  <c:v>sll1581
p=0.002</c:v>
                </c:pt>
                <c:pt idx="2">
                  <c:v>slr1875
p=0.058</c:v>
                </c:pt>
              </c:strCache>
            </c:strRef>
          </c:cat>
          <c:val>
            <c:numRef>
              <c:f>Analysis!$F$3:$F$5</c:f>
              <c:numCache>
                <c:formatCode>General</c:formatCode>
                <c:ptCount val="3"/>
                <c:pt idx="0">
                  <c:v>52.231933333333338</c:v>
                </c:pt>
                <c:pt idx="1">
                  <c:v>36.91746666666667</c:v>
                </c:pt>
                <c:pt idx="2">
                  <c:v>18.9993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6C8-3647-89BD-AC0D50F52DC5}"/>
            </c:ext>
          </c:extLst>
        </c:ser>
        <c:ser>
          <c:idx val="1"/>
          <c:order val="1"/>
          <c:tx>
            <c:strRef>
              <c:f>Analysis!$B$7</c:f>
              <c:strCache>
                <c:ptCount val="1"/>
                <c:pt idx="0">
                  <c:v>Late growth, low S</c:v>
                </c:pt>
              </c:strCache>
            </c:strRef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Analysis!$G$8:$G$10</c:f>
                <c:numCache>
                  <c:formatCode>General</c:formatCode>
                  <c:ptCount val="3"/>
                  <c:pt idx="0">
                    <c:v>1.8264320092586095</c:v>
                  </c:pt>
                  <c:pt idx="1">
                    <c:v>2.4283146174067261</c:v>
                  </c:pt>
                  <c:pt idx="2">
                    <c:v>3.8985028430425874</c:v>
                  </c:pt>
                </c:numCache>
              </c:numRef>
            </c:plus>
            <c:minus>
              <c:numRef>
                <c:f>Analysis!$G$8:$G$10</c:f>
                <c:numCache>
                  <c:formatCode>General</c:formatCode>
                  <c:ptCount val="3"/>
                  <c:pt idx="0">
                    <c:v>1.8264320092586095</c:v>
                  </c:pt>
                  <c:pt idx="1">
                    <c:v>2.4283146174067261</c:v>
                  </c:pt>
                  <c:pt idx="2">
                    <c:v>3.8985028430425874</c:v>
                  </c:pt>
                </c:numCache>
              </c:numRef>
            </c:minus>
            <c:spPr>
              <a:ln>
                <a:solidFill>
                  <a:schemeClr val="tx1">
                    <a:lumMod val="85000"/>
                    <a:lumOff val="15000"/>
                  </a:schemeClr>
                </a:solidFill>
              </a:ln>
            </c:spPr>
          </c:errBars>
          <c:cat>
            <c:strRef>
              <c:f>Analysis!$B$3:$B$5</c:f>
              <c:strCache>
                <c:ptCount val="3"/>
                <c:pt idx="0">
                  <c:v>sll0923
p=0.003</c:v>
                </c:pt>
                <c:pt idx="1">
                  <c:v>sll1581
p=0.002</c:v>
                </c:pt>
                <c:pt idx="2">
                  <c:v>slr1875
p=0.058</c:v>
                </c:pt>
              </c:strCache>
            </c:strRef>
          </c:cat>
          <c:val>
            <c:numRef>
              <c:f>Analysis!$F$8:$F$10</c:f>
              <c:numCache>
                <c:formatCode>General</c:formatCode>
                <c:ptCount val="3"/>
                <c:pt idx="0">
                  <c:v>34.553233333333331</c:v>
                </c:pt>
                <c:pt idx="1">
                  <c:v>23.590066666666662</c:v>
                </c:pt>
                <c:pt idx="2">
                  <c:v>13.10245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6C8-3647-89BD-AC0D50F52DC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7402368"/>
        <c:axId val="127403904"/>
      </c:barChart>
      <c:catAx>
        <c:axId val="1274023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>
                <a:lumMod val="85000"/>
                <a:lumOff val="15000"/>
              </a:schemeClr>
            </a:solidFill>
          </a:ln>
        </c:spPr>
        <c:txPr>
          <a:bodyPr rot="0" vert="horz"/>
          <a:lstStyle/>
          <a:p>
            <a:pPr>
              <a:defRPr sz="1000"/>
            </a:pPr>
            <a:endParaRPr lang="en-US"/>
          </a:p>
        </c:txPr>
        <c:crossAx val="127403904"/>
        <c:crosses val="autoZero"/>
        <c:auto val="1"/>
        <c:lblAlgn val="ctr"/>
        <c:lblOffset val="100"/>
        <c:noMultiLvlLbl val="0"/>
      </c:catAx>
      <c:valAx>
        <c:axId val="1274039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>
                <a:lumMod val="85000"/>
                <a:lumOff val="15000"/>
              </a:schemeClr>
            </a:solidFill>
          </a:ln>
        </c:spPr>
        <c:txPr>
          <a:bodyPr/>
          <a:lstStyle/>
          <a:p>
            <a:pPr>
              <a:defRPr sz="1000"/>
            </a:pPr>
            <a:endParaRPr lang="en-US"/>
          </a:p>
        </c:txPr>
        <c:crossAx val="127402368"/>
        <c:crosses val="autoZero"/>
        <c:crossBetween val="between"/>
        <c:majorUnit val="20"/>
      </c:valAx>
      <c:spPr>
        <a:noFill/>
        <a:ln w="25400">
          <a:noFill/>
        </a:ln>
      </c:spPr>
    </c:plotArea>
    <c:legend>
      <c:legendPos val="t"/>
      <c:layout>
        <c:manualLayout>
          <c:xMode val="edge"/>
          <c:yMode val="edge"/>
          <c:x val="0.19376861114541741"/>
          <c:y val="0"/>
          <c:w val="0.79120982165319576"/>
          <c:h val="0.11825659832741997"/>
        </c:manualLayout>
      </c:layout>
      <c:overlay val="0"/>
      <c:txPr>
        <a:bodyPr/>
        <a:lstStyle/>
        <a:p>
          <a:pPr>
            <a:defRPr sz="1000"/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200"/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585FBD2-0607-4BE6-BB5E-1D6E6DF51AFE}" type="datetimeFigureOut">
              <a:rPr lang="en-GB" smtClean="0"/>
              <a:t>29/06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504D194-39D5-47FB-80A6-A05EB3F195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9505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504D194-39D5-47FB-80A6-A05EB3F195FC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51396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72" indent="0" algn="ctr">
              <a:buNone/>
              <a:defRPr sz="1500"/>
            </a:lvl2pPr>
            <a:lvl3pPr marL="685743" indent="0" algn="ctr">
              <a:buNone/>
              <a:defRPr sz="1350"/>
            </a:lvl3pPr>
            <a:lvl4pPr marL="1028614" indent="0" algn="ctr">
              <a:buNone/>
              <a:defRPr sz="1200"/>
            </a:lvl4pPr>
            <a:lvl5pPr marL="1371486" indent="0" algn="ctr">
              <a:buNone/>
              <a:defRPr sz="1200"/>
            </a:lvl5pPr>
            <a:lvl6pPr marL="1714356" indent="0" algn="ctr">
              <a:buNone/>
              <a:defRPr sz="1200"/>
            </a:lvl6pPr>
            <a:lvl7pPr marL="2057228" indent="0" algn="ctr">
              <a:buNone/>
              <a:defRPr sz="1200"/>
            </a:lvl7pPr>
            <a:lvl8pPr marL="2400098" indent="0" algn="ctr">
              <a:buNone/>
              <a:defRPr sz="1200"/>
            </a:lvl8pPr>
            <a:lvl9pPr marL="274297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A650F9-C300-4B80-B401-DA644E6FE887}" type="datetimeFigureOut">
              <a:rPr lang="en-GB" smtClean="0"/>
              <a:t>29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1614B-192A-4A86-BEC7-F35B7180818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64488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A650F9-C300-4B80-B401-DA644E6FE887}" type="datetimeFigureOut">
              <a:rPr lang="en-GB" smtClean="0"/>
              <a:t>29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1614B-192A-4A86-BEC7-F35B7180818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3600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A650F9-C300-4B80-B401-DA644E6FE887}" type="datetimeFigureOut">
              <a:rPr lang="en-GB" smtClean="0"/>
              <a:t>29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1614B-192A-4A86-BEC7-F35B7180818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75211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A650F9-C300-4B80-B401-DA644E6FE887}" type="datetimeFigureOut">
              <a:rPr lang="en-GB" smtClean="0"/>
              <a:t>29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1614B-192A-4A86-BEC7-F35B7180818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385592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8" y="2469625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8" y="6629229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72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43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48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35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2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09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297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A650F9-C300-4B80-B401-DA644E6FE887}" type="datetimeFigureOut">
              <a:rPr lang="en-GB" smtClean="0"/>
              <a:t>29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1614B-192A-4A86-BEC7-F35B7180818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48354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A650F9-C300-4B80-B401-DA644E6FE887}" type="datetimeFigureOut">
              <a:rPr lang="en-GB" smtClean="0"/>
              <a:t>29/0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1614B-192A-4A86-BEC7-F35B7180818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10996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3" y="527406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72" indent="0">
              <a:buNone/>
              <a:defRPr sz="1500" b="1"/>
            </a:lvl2pPr>
            <a:lvl3pPr marL="685743" indent="0">
              <a:buNone/>
              <a:defRPr sz="1350" b="1"/>
            </a:lvl3pPr>
            <a:lvl4pPr marL="1028614" indent="0">
              <a:buNone/>
              <a:defRPr sz="1200" b="1"/>
            </a:lvl4pPr>
            <a:lvl5pPr marL="1371486" indent="0">
              <a:buNone/>
              <a:defRPr sz="1200" b="1"/>
            </a:lvl5pPr>
            <a:lvl6pPr marL="1714356" indent="0">
              <a:buNone/>
              <a:defRPr sz="1200" b="1"/>
            </a:lvl6pPr>
            <a:lvl7pPr marL="2057228" indent="0">
              <a:buNone/>
              <a:defRPr sz="1200" b="1"/>
            </a:lvl7pPr>
            <a:lvl8pPr marL="2400098" indent="0">
              <a:buNone/>
              <a:defRPr sz="1200" b="1"/>
            </a:lvl8pPr>
            <a:lvl9pPr marL="274297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72" indent="0">
              <a:buNone/>
              <a:defRPr sz="1500" b="1"/>
            </a:lvl2pPr>
            <a:lvl3pPr marL="685743" indent="0">
              <a:buNone/>
              <a:defRPr sz="1350" b="1"/>
            </a:lvl3pPr>
            <a:lvl4pPr marL="1028614" indent="0">
              <a:buNone/>
              <a:defRPr sz="1200" b="1"/>
            </a:lvl4pPr>
            <a:lvl5pPr marL="1371486" indent="0">
              <a:buNone/>
              <a:defRPr sz="1200" b="1"/>
            </a:lvl5pPr>
            <a:lvl6pPr marL="1714356" indent="0">
              <a:buNone/>
              <a:defRPr sz="1200" b="1"/>
            </a:lvl6pPr>
            <a:lvl7pPr marL="2057228" indent="0">
              <a:buNone/>
              <a:defRPr sz="1200" b="1"/>
            </a:lvl7pPr>
            <a:lvl8pPr marL="2400098" indent="0">
              <a:buNone/>
              <a:defRPr sz="1200" b="1"/>
            </a:lvl8pPr>
            <a:lvl9pPr marL="274297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A650F9-C300-4B80-B401-DA644E6FE887}" type="datetimeFigureOut">
              <a:rPr lang="en-GB" smtClean="0"/>
              <a:t>29/06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1614B-192A-4A86-BEC7-F35B7180818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488249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A650F9-C300-4B80-B401-DA644E6FE887}" type="datetimeFigureOut">
              <a:rPr lang="en-GB" smtClean="0"/>
              <a:t>29/06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1614B-192A-4A86-BEC7-F35B7180818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616255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A650F9-C300-4B80-B401-DA644E6FE887}" type="datetimeFigureOut">
              <a:rPr lang="en-GB" smtClean="0"/>
              <a:t>29/06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1614B-192A-4A86-BEC7-F35B7180818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02463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5" y="1426285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72" indent="0">
              <a:buNone/>
              <a:defRPr sz="1050"/>
            </a:lvl2pPr>
            <a:lvl3pPr marL="685743" indent="0">
              <a:buNone/>
              <a:defRPr sz="900"/>
            </a:lvl3pPr>
            <a:lvl4pPr marL="1028614" indent="0">
              <a:buNone/>
              <a:defRPr sz="750"/>
            </a:lvl4pPr>
            <a:lvl5pPr marL="1371486" indent="0">
              <a:buNone/>
              <a:defRPr sz="750"/>
            </a:lvl5pPr>
            <a:lvl6pPr marL="1714356" indent="0">
              <a:buNone/>
              <a:defRPr sz="750"/>
            </a:lvl6pPr>
            <a:lvl7pPr marL="2057228" indent="0">
              <a:buNone/>
              <a:defRPr sz="750"/>
            </a:lvl7pPr>
            <a:lvl8pPr marL="2400098" indent="0">
              <a:buNone/>
              <a:defRPr sz="750"/>
            </a:lvl8pPr>
            <a:lvl9pPr marL="274297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A650F9-C300-4B80-B401-DA644E6FE887}" type="datetimeFigureOut">
              <a:rPr lang="en-GB" smtClean="0"/>
              <a:t>29/0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1614B-192A-4A86-BEC7-F35B7180818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11367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5" y="1426285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72" indent="0">
              <a:buNone/>
              <a:defRPr sz="2100"/>
            </a:lvl2pPr>
            <a:lvl3pPr marL="685743" indent="0">
              <a:buNone/>
              <a:defRPr sz="1800"/>
            </a:lvl3pPr>
            <a:lvl4pPr marL="1028614" indent="0">
              <a:buNone/>
              <a:defRPr sz="1500"/>
            </a:lvl4pPr>
            <a:lvl5pPr marL="1371486" indent="0">
              <a:buNone/>
              <a:defRPr sz="1500"/>
            </a:lvl5pPr>
            <a:lvl6pPr marL="1714356" indent="0">
              <a:buNone/>
              <a:defRPr sz="1500"/>
            </a:lvl6pPr>
            <a:lvl7pPr marL="2057228" indent="0">
              <a:buNone/>
              <a:defRPr sz="1500"/>
            </a:lvl7pPr>
            <a:lvl8pPr marL="2400098" indent="0">
              <a:buNone/>
              <a:defRPr sz="1500"/>
            </a:lvl8pPr>
            <a:lvl9pPr marL="274297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72" indent="0">
              <a:buNone/>
              <a:defRPr sz="1050"/>
            </a:lvl2pPr>
            <a:lvl3pPr marL="685743" indent="0">
              <a:buNone/>
              <a:defRPr sz="900"/>
            </a:lvl3pPr>
            <a:lvl4pPr marL="1028614" indent="0">
              <a:buNone/>
              <a:defRPr sz="750"/>
            </a:lvl4pPr>
            <a:lvl5pPr marL="1371486" indent="0">
              <a:buNone/>
              <a:defRPr sz="750"/>
            </a:lvl5pPr>
            <a:lvl6pPr marL="1714356" indent="0">
              <a:buNone/>
              <a:defRPr sz="750"/>
            </a:lvl6pPr>
            <a:lvl7pPr marL="2057228" indent="0">
              <a:buNone/>
              <a:defRPr sz="750"/>
            </a:lvl7pPr>
            <a:lvl8pPr marL="2400098" indent="0">
              <a:buNone/>
              <a:defRPr sz="750"/>
            </a:lvl8pPr>
            <a:lvl9pPr marL="274297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A650F9-C300-4B80-B401-DA644E6FE887}" type="datetimeFigureOut">
              <a:rPr lang="en-GB" smtClean="0"/>
              <a:t>29/0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1614B-192A-4A86-BEC7-F35B7180818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11258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90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90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A650F9-C300-4B80-B401-DA644E6FE887}" type="datetimeFigureOut">
              <a:rPr lang="en-GB" smtClean="0"/>
              <a:t>29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5" y="9181399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A1614B-192A-4A86-BEC7-F35B7180818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61826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743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36" indent="-171436" algn="l" defTabSz="685743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06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178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049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2921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792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664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535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406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72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43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14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486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356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228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098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2970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ADFC03C-2002-3F58-6B70-ECF2626FCBB1}"/>
              </a:ext>
            </a:extLst>
          </p:cNvPr>
          <p:cNvSpPr txBox="1"/>
          <p:nvPr/>
        </p:nvSpPr>
        <p:spPr>
          <a:xfrm>
            <a:off x="907474" y="979735"/>
            <a:ext cx="5320144" cy="286232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ournal: Applied Microbiology and Biotechnology </a:t>
            </a:r>
          </a:p>
          <a:p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tle: Environmental modulation of exopolysaccharide production in the cyanobacterium </a:t>
            </a:r>
            <a:r>
              <a:rPr lang="en-GB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ynechocysti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6803 </a:t>
            </a:r>
          </a:p>
          <a:p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uthors: Mary Ann Madsen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Stefan Semerdzhiev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Jordan D Twigg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laire Moss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harles D Bavington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na Amtmann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ffiliations: 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chool of Molecular Biosciences, College of Medical, Veterinary, and Life Sciences, University of Glasgow, Glasgow G12 8QQ, Scotland, United Kingdom 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ycoMar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td,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lin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ouse, European Marine Science Park, Oban PA37 1SZ, Scotland, United Kingdom </a:t>
            </a:r>
          </a:p>
          <a:p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sponding author: Anna Amtmann Email: anna.amtmann@glasgow.ac.uk Telephone: +44 141 330 5393</a:t>
            </a:r>
          </a:p>
        </p:txBody>
      </p:sp>
    </p:spTree>
    <p:extLst>
      <p:ext uri="{BB962C8B-B14F-4D97-AF65-F5344CB8AC3E}">
        <p14:creationId xmlns:p14="http://schemas.microsoft.com/office/powerpoint/2010/main" val="17299946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TextBox 41">
            <a:extLst>
              <a:ext uri="{FF2B5EF4-FFF2-40B4-BE49-F238E27FC236}">
                <a16:creationId xmlns:a16="http://schemas.microsoft.com/office/drawing/2014/main" id="{065451BF-3FAB-4C17-82B4-F8954024BB50}"/>
              </a:ext>
            </a:extLst>
          </p:cNvPr>
          <p:cNvSpPr txBox="1"/>
          <p:nvPr/>
        </p:nvSpPr>
        <p:spPr>
          <a:xfrm>
            <a:off x="778845" y="1660072"/>
            <a:ext cx="43148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A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8CD860D9-E29D-4222-80E6-966EFC12D80E}"/>
              </a:ext>
            </a:extLst>
          </p:cNvPr>
          <p:cNvSpPr txBox="1"/>
          <p:nvPr/>
        </p:nvSpPr>
        <p:spPr>
          <a:xfrm>
            <a:off x="3347227" y="1656061"/>
            <a:ext cx="43761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B</a:t>
            </a:r>
          </a:p>
        </p:txBody>
      </p:sp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D2CA0632-D86D-DD0D-BFC3-562EE45ECD5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94136324"/>
              </p:ext>
            </p:extLst>
          </p:nvPr>
        </p:nvGraphicFramePr>
        <p:xfrm>
          <a:off x="1018473" y="1751372"/>
          <a:ext cx="2171700" cy="25969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4" name="Chart 13">
            <a:extLst>
              <a:ext uri="{FF2B5EF4-FFF2-40B4-BE49-F238E27FC236}">
                <a16:creationId xmlns:a16="http://schemas.microsoft.com/office/drawing/2014/main" id="{A33A27A8-5133-B63B-77DD-1B8BF7AF173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98529560"/>
              </p:ext>
            </p:extLst>
          </p:nvPr>
        </p:nvGraphicFramePr>
        <p:xfrm>
          <a:off x="3571834" y="1751372"/>
          <a:ext cx="2186190" cy="25969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DFF598D9-BDFA-9E72-4092-3DD3E7748C22}"/>
              </a:ext>
            </a:extLst>
          </p:cNvPr>
          <p:cNvSpPr txBox="1"/>
          <p:nvPr/>
        </p:nvSpPr>
        <p:spPr>
          <a:xfrm>
            <a:off x="673278" y="4935301"/>
            <a:ext cx="5511444" cy="12447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GB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1 </a:t>
            </a:r>
            <a:r>
              <a:rPr lang="en-GB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Expression levels of EPS biosynthesis genes in different growth phases and media</a:t>
            </a:r>
            <a:br>
              <a:rPr lang="en-GB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</a:br>
            <a:r>
              <a:rPr lang="en-GB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ranscript levels (normalised to gene length and read counts as FPKM) from published RNA sequencing dataset of early (white bars) and late (black bars) growth phases of </a:t>
            </a:r>
            <a:r>
              <a:rPr lang="en-GB" sz="110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ynechocystis</a:t>
            </a:r>
            <a:r>
              <a:rPr lang="en-GB" sz="11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GB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ultivated in </a:t>
            </a:r>
            <a:r>
              <a:rPr lang="en-GB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A)</a:t>
            </a:r>
            <a:r>
              <a:rPr lang="en-GB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12.5% Mg and </a:t>
            </a:r>
            <a:r>
              <a:rPr lang="en-GB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B)</a:t>
            </a:r>
            <a:r>
              <a:rPr lang="en-GB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12.5% S in BG11 background (Madsen et al., 2020). Data are m</a:t>
            </a:r>
            <a:r>
              <a:rPr lang="en-GB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ans ± S.E.M. of three independent cultures. St</a:t>
            </a:r>
            <a:r>
              <a:rPr lang="en-GB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tistical significance of difference between early and late growth expression levels for each gene was determined using </a:t>
            </a:r>
            <a:r>
              <a:rPr lang="en-GB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uffdiff</a:t>
            </a:r>
            <a:r>
              <a:rPr lang="en-GB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software.</a:t>
            </a:r>
          </a:p>
        </p:txBody>
      </p:sp>
    </p:spTree>
    <p:extLst>
      <p:ext uri="{BB962C8B-B14F-4D97-AF65-F5344CB8AC3E}">
        <p14:creationId xmlns:p14="http://schemas.microsoft.com/office/powerpoint/2010/main" val="5513525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EB7C3E2FE4D6A74FB9879DB27C6834CE" ma:contentTypeVersion="7" ma:contentTypeDescription="Create a new document." ma:contentTypeScope="" ma:versionID="8c6dcb2aec29f852b21fd2e09af7bb54">
  <xsd:schema xmlns:xsd="http://www.w3.org/2001/XMLSchema" xmlns:xs="http://www.w3.org/2001/XMLSchema" xmlns:p="http://schemas.microsoft.com/office/2006/metadata/properties" xmlns:ns3="2bb6afd6-b189-493e-90d9-1728c8281296" xmlns:ns4="540e88c8-237c-405e-8a77-e6d41fa5383c" targetNamespace="http://schemas.microsoft.com/office/2006/metadata/properties" ma:root="true" ma:fieldsID="2b6355cd93496c7f783883a226f18610" ns3:_="" ns4:_="">
    <xsd:import namespace="2bb6afd6-b189-493e-90d9-1728c8281296"/>
    <xsd:import namespace="540e88c8-237c-405e-8a77-e6d41fa5383c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bb6afd6-b189-493e-90d9-1728c828129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40e88c8-237c-405e-8a77-e6d41fa5383c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4794647B-1BA0-4770-8050-9BFD1A7186FF}">
  <ds:schemaRefs>
    <ds:schemaRef ds:uri="http://schemas.microsoft.com/office/infopath/2007/PartnerControls"/>
    <ds:schemaRef ds:uri="540e88c8-237c-405e-8a77-e6d41fa5383c"/>
    <ds:schemaRef ds:uri="http://schemas.microsoft.com/office/2006/documentManagement/types"/>
    <ds:schemaRef ds:uri="http://purl.org/dc/dcmitype/"/>
    <ds:schemaRef ds:uri="http://schemas.microsoft.com/office/2006/metadata/properties"/>
    <ds:schemaRef ds:uri="http://purl.org/dc/elements/1.1/"/>
    <ds:schemaRef ds:uri="http://schemas.openxmlformats.org/package/2006/metadata/core-properties"/>
    <ds:schemaRef ds:uri="2bb6afd6-b189-493e-90d9-1728c8281296"/>
    <ds:schemaRef ds:uri="http://www.w3.org/XML/1998/namespace"/>
    <ds:schemaRef ds:uri="http://purl.org/dc/terms/"/>
  </ds:schemaRefs>
</ds:datastoreItem>
</file>

<file path=customXml/itemProps2.xml><?xml version="1.0" encoding="utf-8"?>
<ds:datastoreItem xmlns:ds="http://schemas.openxmlformats.org/officeDocument/2006/customXml" ds:itemID="{5FAF1058-67DD-4AA2-801D-C1C9A9BA510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2bb6afd6-b189-493e-90d9-1728c8281296"/>
    <ds:schemaRef ds:uri="540e88c8-237c-405e-8a77-e6d41fa5383c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E3FA2A1D-04EF-4004-897F-21C067C2066A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393</TotalTime>
  <Words>226</Words>
  <Application>Microsoft Office PowerPoint</Application>
  <PresentationFormat>A4 Paper (210x297 mm)</PresentationFormat>
  <Paragraphs>13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>University Of Glasgow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y Ann Madsen</dc:creator>
  <cp:lastModifiedBy>Anna Amtmann</cp:lastModifiedBy>
  <cp:revision>909</cp:revision>
  <dcterms:created xsi:type="dcterms:W3CDTF">2019-05-08T16:22:36Z</dcterms:created>
  <dcterms:modified xsi:type="dcterms:W3CDTF">2023-06-29T15:07:0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B7C3E2FE4D6A74FB9879DB27C6834CE</vt:lpwstr>
  </property>
</Properties>
</file>